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9900"/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154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______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'210724新図1'!$E$6:$E$9</c:f>
              <c:numCache>
                <c:formatCode>General</c:formatCode>
                <c:ptCount val="4"/>
                <c:pt idx="0">
                  <c:v>33.5</c:v>
                </c:pt>
                <c:pt idx="1">
                  <c:v>33.1</c:v>
                </c:pt>
                <c:pt idx="2">
                  <c:v>30.3</c:v>
                </c:pt>
                <c:pt idx="3">
                  <c:v>28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7C-4093-985D-B860795BFC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9"/>
        <c:axId val="1899868223"/>
        <c:axId val="1899861151"/>
      </c:barChart>
      <c:catAx>
        <c:axId val="18998682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9861151"/>
        <c:crosses val="autoZero"/>
        <c:auto val="1"/>
        <c:lblAlgn val="ctr"/>
        <c:lblOffset val="100"/>
        <c:noMultiLvlLbl val="0"/>
      </c:catAx>
      <c:valAx>
        <c:axId val="1899861151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200" b="0" i="0" baseline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ge- sex-adjusted incidence rate</a:t>
                </a:r>
                <a:endParaRPr lang="ja-JP" altLang="ja-JP" sz="120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200" b="0" i="0" baseline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per 10</a:t>
                </a:r>
                <a:r>
                  <a:rPr lang="en-US" altLang="ja-JP" sz="1200" b="0" i="0" baseline="3000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ja-JP" sz="1200" b="0" i="0" baseline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PYs)</a:t>
                </a:r>
                <a:endParaRPr lang="ja-JP" altLang="ja-JP" sz="120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ja-JP" altLang="en-US" sz="12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0555555555555555E-2"/>
              <c:y val="5.706036745406824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9986822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'210724新図1'!$N$6:$N$9</c:f>
              <c:numCache>
                <c:formatCode>General</c:formatCode>
                <c:ptCount val="4"/>
                <c:pt idx="0">
                  <c:v>34.299999999999997</c:v>
                </c:pt>
                <c:pt idx="1">
                  <c:v>31.2</c:v>
                </c:pt>
                <c:pt idx="2">
                  <c:v>29.4</c:v>
                </c:pt>
                <c:pt idx="3">
                  <c:v>3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E8-421E-A7E7-5D6A2AB010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756049983"/>
        <c:axId val="1756052479"/>
      </c:barChart>
      <c:catAx>
        <c:axId val="1756049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56052479"/>
        <c:crosses val="autoZero"/>
        <c:auto val="1"/>
        <c:lblAlgn val="ctr"/>
        <c:lblOffset val="100"/>
        <c:noMultiLvlLbl val="0"/>
      </c:catAx>
      <c:valAx>
        <c:axId val="1756052479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200" b="0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ge- sex-adjusted incidence rate</a:t>
                </a:r>
                <a:endParaRPr lang="ja-JP" altLang="ja-JP" sz="120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200" b="0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per 10</a:t>
                </a:r>
                <a:r>
                  <a:rPr lang="en-US" altLang="ja-JP" sz="1200" b="0" i="0" baseline="3000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ja-JP" sz="1200" b="0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PYs)</a:t>
                </a:r>
                <a:endParaRPr lang="ja-JP" altLang="ja-JP" sz="120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ja-JP" altLang="en-US" sz="1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5604998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CB4B8-7CB4-4564-8F64-8D9F8E9680E8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3770A9-9387-4F4A-A39C-46F2A1AB3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0006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3770A9-9387-4F4A-A39C-46F2A1AB3F9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860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050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046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462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179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154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217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9849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3095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616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019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4703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421B0-5C23-403A-81D2-AA7D708F97EE}" type="datetimeFigureOut">
              <a:rPr kumimoji="1" lang="ja-JP" altLang="en-US" smtClean="0"/>
              <a:t>2021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0BC4D-B868-4626-9934-4DC7CBF7C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728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1565243"/>
              </p:ext>
            </p:extLst>
          </p:nvPr>
        </p:nvGraphicFramePr>
        <p:xfrm>
          <a:off x="477887" y="1263460"/>
          <a:ext cx="3668663" cy="2446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4645536"/>
              </p:ext>
            </p:extLst>
          </p:nvPr>
        </p:nvGraphicFramePr>
        <p:xfrm>
          <a:off x="4807814" y="1263461"/>
          <a:ext cx="3741487" cy="2411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7" name="直線コネクタ 6"/>
          <p:cNvCxnSpPr/>
          <p:nvPr/>
        </p:nvCxnSpPr>
        <p:spPr>
          <a:xfrm>
            <a:off x="1577160" y="3684864"/>
            <a:ext cx="24905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1317840" y="3438889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632023" y="3436177"/>
            <a:ext cx="45397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67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254836" y="3438134"/>
            <a:ext cx="55791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68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876620" y="3442177"/>
            <a:ext cx="571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69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493172" y="3439728"/>
            <a:ext cx="45397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67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702927" y="3682486"/>
            <a:ext cx="2547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Q1             </a:t>
            </a:r>
            <a:r>
              <a:rPr lang="en-US" altLang="ja-JP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Q2            Q3             Q4</a:t>
            </a:r>
            <a:endParaRPr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>
            <a:off x="6065520" y="3660800"/>
            <a:ext cx="24109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6135984" y="3405120"/>
            <a:ext cx="45397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300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726625" y="3404344"/>
            <a:ext cx="45397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05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303879" y="3408820"/>
            <a:ext cx="52108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98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905283" y="3406801"/>
            <a:ext cx="453970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68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181748" y="3660799"/>
            <a:ext cx="2220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Q1             </a:t>
            </a:r>
            <a:r>
              <a:rPr lang="en-US" altLang="ja-JP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Q2          Q3             Q4</a:t>
            </a:r>
            <a:endParaRPr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806760" y="3399914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25555" y="820227"/>
            <a:ext cx="31611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b="1" dirty="0"/>
              <a:t>A</a:t>
            </a:r>
            <a:endParaRPr lang="ja-JP" altLang="en-US" sz="1500" b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852270" y="821055"/>
            <a:ext cx="32092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b="1" dirty="0"/>
              <a:t>B</a:t>
            </a:r>
            <a:endParaRPr lang="ja-JP" altLang="en-US" sz="1500" b="1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917501" y="3879002"/>
            <a:ext cx="1779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egetable intake, g/da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661762" y="3861660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ruit intake, g/da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970394" y="1116815"/>
            <a:ext cx="10422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trend = 0.03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358067" y="1101911"/>
            <a:ext cx="10422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trend = 0.01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653571" y="4204749"/>
            <a:ext cx="2036826" cy="4445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350" b="1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</a:t>
            </a:r>
            <a:r>
              <a:rPr lang="en-US" altLang="ja-JP" sz="135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US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53571" y="5137316"/>
            <a:ext cx="7631627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incidence of dementia was calculated by the person-years method. </a:t>
            </a:r>
            <a:r>
              <a:rPr lang="en-US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age- and sex-adjusted incidence</a:t>
            </a:r>
          </a:p>
          <a:p>
            <a:r>
              <a:rPr lang="en-US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ates of total dementia were calculated using a Poisson regression model including age and sex, where </a:t>
            </a:r>
          </a:p>
          <a:p>
            <a:r>
              <a:rPr lang="en-US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variables of log-transformed person-years were used as the offset term.</a:t>
            </a:r>
            <a:endParaRPr lang="ja-JP" altLang="ja-JP" sz="9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53571" y="4565457"/>
            <a:ext cx="7435049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ge- and sex-adjusted incidence of total dementia according to quartiles of  the absolute values of the </a:t>
            </a:r>
          </a:p>
          <a:p>
            <a:r>
              <a:rPr lang="en-GB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getable (A) and fruit intake (B) at baseline</a:t>
            </a:r>
            <a:r>
              <a:rPr lang="en-GB" altLang="ja-JP" sz="1350" kern="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350" kern="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n older Japanese adults</a:t>
            </a:r>
            <a:r>
              <a:rPr lang="en-US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ja-JP" altLang="ja-JP" sz="1350" kern="100" dirty="0"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ged </a:t>
            </a:r>
            <a:r>
              <a:rPr lang="en-US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≥</a:t>
            </a:r>
            <a:r>
              <a:rPr lang="ja-JP" altLang="ja-JP" sz="1350" kern="100" dirty="0"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60 years </a:t>
            </a:r>
            <a:r>
              <a:rPr lang="en-GB" altLang="ja-JP" sz="13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rom 1988–2012.</a:t>
            </a:r>
            <a:r>
              <a:rPr lang="en-GB" altLang="ja-JP" sz="1350" kern="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</a:p>
          <a:p>
            <a:endParaRPr lang="ja-JP" altLang="en-US" sz="1350" dirty="0"/>
          </a:p>
        </p:txBody>
      </p:sp>
    </p:spTree>
    <p:extLst>
      <p:ext uri="{BB962C8B-B14F-4D97-AF65-F5344CB8AC3E}">
        <p14:creationId xmlns:p14="http://schemas.microsoft.com/office/powerpoint/2010/main" val="2773020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29</TotalTime>
  <Words>163</Words>
  <Application>Microsoft Office PowerPoint</Application>
  <PresentationFormat>画面に合わせる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kimura</dc:creator>
  <cp:lastModifiedBy>yasumi kimura</cp:lastModifiedBy>
  <cp:revision>214</cp:revision>
  <cp:lastPrinted>2019-08-27T04:37:26Z</cp:lastPrinted>
  <dcterms:created xsi:type="dcterms:W3CDTF">2019-08-09T06:33:10Z</dcterms:created>
  <dcterms:modified xsi:type="dcterms:W3CDTF">2021-09-08T10:07:14Z</dcterms:modified>
</cp:coreProperties>
</file>